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5"/>
  </p:notesMasterIdLst>
  <p:sldIdLst>
    <p:sldId id="262" r:id="rId2"/>
    <p:sldId id="261" r:id="rId3"/>
    <p:sldId id="260" r:id="rId4"/>
  </p:sldIdLst>
  <p:sldSz cx="7920038" cy="9144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E8BF9"/>
    <a:srgbClr val="FFC08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8" d="100"/>
          <a:sy n="78" d="100"/>
        </p:scale>
        <p:origin x="43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CF8A970-160D-4902-8D5E-1B6FDF4563AB}" type="datetimeFigureOut">
              <a:rPr lang="zh-CN" altLang="en-US" smtClean="0"/>
              <a:t>2022/3/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093913" y="1143000"/>
            <a:ext cx="26701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0A28479-3798-4B25-AABD-FA765594C6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654151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94003" y="1496484"/>
            <a:ext cx="6732032" cy="3183467"/>
          </a:xfrm>
        </p:spPr>
        <p:txBody>
          <a:bodyPr anchor="b"/>
          <a:lstStyle>
            <a:lvl1pPr algn="ctr">
              <a:defRPr sz="519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90005" y="4802717"/>
            <a:ext cx="5940029" cy="2207683"/>
          </a:xfrm>
        </p:spPr>
        <p:txBody>
          <a:bodyPr/>
          <a:lstStyle>
            <a:lvl1pPr marL="0" indent="0" algn="ctr">
              <a:buNone/>
              <a:defRPr sz="2079"/>
            </a:lvl1pPr>
            <a:lvl2pPr marL="395981" indent="0" algn="ctr">
              <a:buNone/>
              <a:defRPr sz="1732"/>
            </a:lvl2pPr>
            <a:lvl3pPr marL="791962" indent="0" algn="ctr">
              <a:buNone/>
              <a:defRPr sz="1559"/>
            </a:lvl3pPr>
            <a:lvl4pPr marL="1187943" indent="0" algn="ctr">
              <a:buNone/>
              <a:defRPr sz="1386"/>
            </a:lvl4pPr>
            <a:lvl5pPr marL="1583924" indent="0" algn="ctr">
              <a:buNone/>
              <a:defRPr sz="1386"/>
            </a:lvl5pPr>
            <a:lvl6pPr marL="1979905" indent="0" algn="ctr">
              <a:buNone/>
              <a:defRPr sz="1386"/>
            </a:lvl6pPr>
            <a:lvl7pPr marL="2375886" indent="0" algn="ctr">
              <a:buNone/>
              <a:defRPr sz="1386"/>
            </a:lvl7pPr>
            <a:lvl8pPr marL="2771866" indent="0" algn="ctr">
              <a:buNone/>
              <a:defRPr sz="1386"/>
            </a:lvl8pPr>
            <a:lvl9pPr marL="3167847" indent="0" algn="ctr">
              <a:buNone/>
              <a:defRPr sz="1386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18134-4681-4C19-9489-6E01CC32B0AC}" type="datetimeFigureOut">
              <a:rPr lang="zh-CN" altLang="en-US" smtClean="0"/>
              <a:t>2022/3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4C929B-716C-4F10-932C-E79C3309581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928451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18134-4681-4C19-9489-6E01CC32B0AC}" type="datetimeFigureOut">
              <a:rPr lang="zh-CN" altLang="en-US" smtClean="0"/>
              <a:t>2022/3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4C929B-716C-4F10-932C-E79C3309581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157924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667778" y="486834"/>
            <a:ext cx="1707758" cy="774911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44503" y="486834"/>
            <a:ext cx="5024274" cy="774911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18134-4681-4C19-9489-6E01CC32B0AC}" type="datetimeFigureOut">
              <a:rPr lang="zh-CN" altLang="en-US" smtClean="0"/>
              <a:t>2022/3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4C929B-716C-4F10-932C-E79C3309581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276840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18134-4681-4C19-9489-6E01CC32B0AC}" type="datetimeFigureOut">
              <a:rPr lang="zh-CN" altLang="en-US" smtClean="0"/>
              <a:t>2022/3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4C929B-716C-4F10-932C-E79C3309581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859078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0378" y="2279653"/>
            <a:ext cx="6831033" cy="3803649"/>
          </a:xfrm>
        </p:spPr>
        <p:txBody>
          <a:bodyPr anchor="b"/>
          <a:lstStyle>
            <a:lvl1pPr>
              <a:defRPr sz="519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0378" y="6119286"/>
            <a:ext cx="6831033" cy="2000249"/>
          </a:xfrm>
        </p:spPr>
        <p:txBody>
          <a:bodyPr/>
          <a:lstStyle>
            <a:lvl1pPr marL="0" indent="0">
              <a:buNone/>
              <a:defRPr sz="2079">
                <a:solidFill>
                  <a:schemeClr val="tx1"/>
                </a:solidFill>
              </a:defRPr>
            </a:lvl1pPr>
            <a:lvl2pPr marL="395981" indent="0">
              <a:buNone/>
              <a:defRPr sz="1732">
                <a:solidFill>
                  <a:schemeClr val="tx1">
                    <a:tint val="75000"/>
                  </a:schemeClr>
                </a:solidFill>
              </a:defRPr>
            </a:lvl2pPr>
            <a:lvl3pPr marL="791962" indent="0">
              <a:buNone/>
              <a:defRPr sz="1559">
                <a:solidFill>
                  <a:schemeClr val="tx1">
                    <a:tint val="75000"/>
                  </a:schemeClr>
                </a:solidFill>
              </a:defRPr>
            </a:lvl3pPr>
            <a:lvl4pPr marL="1187943" indent="0">
              <a:buNone/>
              <a:defRPr sz="1386">
                <a:solidFill>
                  <a:schemeClr val="tx1">
                    <a:tint val="75000"/>
                  </a:schemeClr>
                </a:solidFill>
              </a:defRPr>
            </a:lvl4pPr>
            <a:lvl5pPr marL="1583924" indent="0">
              <a:buNone/>
              <a:defRPr sz="1386">
                <a:solidFill>
                  <a:schemeClr val="tx1">
                    <a:tint val="75000"/>
                  </a:schemeClr>
                </a:solidFill>
              </a:defRPr>
            </a:lvl5pPr>
            <a:lvl6pPr marL="1979905" indent="0">
              <a:buNone/>
              <a:defRPr sz="1386">
                <a:solidFill>
                  <a:schemeClr val="tx1">
                    <a:tint val="75000"/>
                  </a:schemeClr>
                </a:solidFill>
              </a:defRPr>
            </a:lvl6pPr>
            <a:lvl7pPr marL="2375886" indent="0">
              <a:buNone/>
              <a:defRPr sz="1386">
                <a:solidFill>
                  <a:schemeClr val="tx1">
                    <a:tint val="75000"/>
                  </a:schemeClr>
                </a:solidFill>
              </a:defRPr>
            </a:lvl7pPr>
            <a:lvl8pPr marL="2771866" indent="0">
              <a:buNone/>
              <a:defRPr sz="1386">
                <a:solidFill>
                  <a:schemeClr val="tx1">
                    <a:tint val="75000"/>
                  </a:schemeClr>
                </a:solidFill>
              </a:defRPr>
            </a:lvl8pPr>
            <a:lvl9pPr marL="3167847" indent="0">
              <a:buNone/>
              <a:defRPr sz="138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18134-4681-4C19-9489-6E01CC32B0AC}" type="datetimeFigureOut">
              <a:rPr lang="zh-CN" altLang="en-US" smtClean="0"/>
              <a:t>2022/3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4C929B-716C-4F10-932C-E79C3309581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417754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44503" y="2434167"/>
            <a:ext cx="3366016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009519" y="2434167"/>
            <a:ext cx="3366016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18134-4681-4C19-9489-6E01CC32B0AC}" type="datetimeFigureOut">
              <a:rPr lang="zh-CN" altLang="en-US" smtClean="0"/>
              <a:t>2022/3/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4C929B-716C-4F10-932C-E79C3309581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940583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5534" y="486836"/>
            <a:ext cx="6831033" cy="1767417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5535" y="2241551"/>
            <a:ext cx="3350547" cy="1098549"/>
          </a:xfrm>
        </p:spPr>
        <p:txBody>
          <a:bodyPr anchor="b"/>
          <a:lstStyle>
            <a:lvl1pPr marL="0" indent="0">
              <a:buNone/>
              <a:defRPr sz="2079" b="1"/>
            </a:lvl1pPr>
            <a:lvl2pPr marL="395981" indent="0">
              <a:buNone/>
              <a:defRPr sz="1732" b="1"/>
            </a:lvl2pPr>
            <a:lvl3pPr marL="791962" indent="0">
              <a:buNone/>
              <a:defRPr sz="1559" b="1"/>
            </a:lvl3pPr>
            <a:lvl4pPr marL="1187943" indent="0">
              <a:buNone/>
              <a:defRPr sz="1386" b="1"/>
            </a:lvl4pPr>
            <a:lvl5pPr marL="1583924" indent="0">
              <a:buNone/>
              <a:defRPr sz="1386" b="1"/>
            </a:lvl5pPr>
            <a:lvl6pPr marL="1979905" indent="0">
              <a:buNone/>
              <a:defRPr sz="1386" b="1"/>
            </a:lvl6pPr>
            <a:lvl7pPr marL="2375886" indent="0">
              <a:buNone/>
              <a:defRPr sz="1386" b="1"/>
            </a:lvl7pPr>
            <a:lvl8pPr marL="2771866" indent="0">
              <a:buNone/>
              <a:defRPr sz="1386" b="1"/>
            </a:lvl8pPr>
            <a:lvl9pPr marL="3167847" indent="0">
              <a:buNone/>
              <a:defRPr sz="1386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45535" y="3340100"/>
            <a:ext cx="3350547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009520" y="2241551"/>
            <a:ext cx="3367048" cy="1098549"/>
          </a:xfrm>
        </p:spPr>
        <p:txBody>
          <a:bodyPr anchor="b"/>
          <a:lstStyle>
            <a:lvl1pPr marL="0" indent="0">
              <a:buNone/>
              <a:defRPr sz="2079" b="1"/>
            </a:lvl1pPr>
            <a:lvl2pPr marL="395981" indent="0">
              <a:buNone/>
              <a:defRPr sz="1732" b="1"/>
            </a:lvl2pPr>
            <a:lvl3pPr marL="791962" indent="0">
              <a:buNone/>
              <a:defRPr sz="1559" b="1"/>
            </a:lvl3pPr>
            <a:lvl4pPr marL="1187943" indent="0">
              <a:buNone/>
              <a:defRPr sz="1386" b="1"/>
            </a:lvl4pPr>
            <a:lvl5pPr marL="1583924" indent="0">
              <a:buNone/>
              <a:defRPr sz="1386" b="1"/>
            </a:lvl5pPr>
            <a:lvl6pPr marL="1979905" indent="0">
              <a:buNone/>
              <a:defRPr sz="1386" b="1"/>
            </a:lvl6pPr>
            <a:lvl7pPr marL="2375886" indent="0">
              <a:buNone/>
              <a:defRPr sz="1386" b="1"/>
            </a:lvl7pPr>
            <a:lvl8pPr marL="2771866" indent="0">
              <a:buNone/>
              <a:defRPr sz="1386" b="1"/>
            </a:lvl8pPr>
            <a:lvl9pPr marL="3167847" indent="0">
              <a:buNone/>
              <a:defRPr sz="1386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009520" y="3340100"/>
            <a:ext cx="3367048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18134-4681-4C19-9489-6E01CC32B0AC}" type="datetimeFigureOut">
              <a:rPr lang="zh-CN" altLang="en-US" smtClean="0"/>
              <a:t>2022/3/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4C929B-716C-4F10-932C-E79C3309581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123468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18134-4681-4C19-9489-6E01CC32B0AC}" type="datetimeFigureOut">
              <a:rPr lang="zh-CN" altLang="en-US" smtClean="0"/>
              <a:t>2022/3/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4C929B-716C-4F10-932C-E79C3309581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414854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18134-4681-4C19-9489-6E01CC32B0AC}" type="datetimeFigureOut">
              <a:rPr lang="zh-CN" altLang="en-US" smtClean="0"/>
              <a:t>2022/3/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4C929B-716C-4F10-932C-E79C3309581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164517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5534" y="609600"/>
            <a:ext cx="2554418" cy="2133600"/>
          </a:xfrm>
        </p:spPr>
        <p:txBody>
          <a:bodyPr anchor="b"/>
          <a:lstStyle>
            <a:lvl1pPr>
              <a:defRPr sz="277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67048" y="1316569"/>
            <a:ext cx="4009519" cy="6498167"/>
          </a:xfrm>
        </p:spPr>
        <p:txBody>
          <a:bodyPr/>
          <a:lstStyle>
            <a:lvl1pPr>
              <a:defRPr sz="2772"/>
            </a:lvl1pPr>
            <a:lvl2pPr>
              <a:defRPr sz="2425"/>
            </a:lvl2pPr>
            <a:lvl3pPr>
              <a:defRPr sz="2079"/>
            </a:lvl3pPr>
            <a:lvl4pPr>
              <a:defRPr sz="1732"/>
            </a:lvl4pPr>
            <a:lvl5pPr>
              <a:defRPr sz="1732"/>
            </a:lvl5pPr>
            <a:lvl6pPr>
              <a:defRPr sz="1732"/>
            </a:lvl6pPr>
            <a:lvl7pPr>
              <a:defRPr sz="1732"/>
            </a:lvl7pPr>
            <a:lvl8pPr>
              <a:defRPr sz="1732"/>
            </a:lvl8pPr>
            <a:lvl9pPr>
              <a:defRPr sz="1732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45534" y="2743200"/>
            <a:ext cx="2554418" cy="5082117"/>
          </a:xfrm>
        </p:spPr>
        <p:txBody>
          <a:bodyPr/>
          <a:lstStyle>
            <a:lvl1pPr marL="0" indent="0">
              <a:buNone/>
              <a:defRPr sz="1386"/>
            </a:lvl1pPr>
            <a:lvl2pPr marL="395981" indent="0">
              <a:buNone/>
              <a:defRPr sz="1213"/>
            </a:lvl2pPr>
            <a:lvl3pPr marL="791962" indent="0">
              <a:buNone/>
              <a:defRPr sz="1039"/>
            </a:lvl3pPr>
            <a:lvl4pPr marL="1187943" indent="0">
              <a:buNone/>
              <a:defRPr sz="866"/>
            </a:lvl4pPr>
            <a:lvl5pPr marL="1583924" indent="0">
              <a:buNone/>
              <a:defRPr sz="866"/>
            </a:lvl5pPr>
            <a:lvl6pPr marL="1979905" indent="0">
              <a:buNone/>
              <a:defRPr sz="866"/>
            </a:lvl6pPr>
            <a:lvl7pPr marL="2375886" indent="0">
              <a:buNone/>
              <a:defRPr sz="866"/>
            </a:lvl7pPr>
            <a:lvl8pPr marL="2771866" indent="0">
              <a:buNone/>
              <a:defRPr sz="866"/>
            </a:lvl8pPr>
            <a:lvl9pPr marL="3167847" indent="0">
              <a:buNone/>
              <a:defRPr sz="866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18134-4681-4C19-9489-6E01CC32B0AC}" type="datetimeFigureOut">
              <a:rPr lang="zh-CN" altLang="en-US" smtClean="0"/>
              <a:t>2022/3/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4C929B-716C-4F10-932C-E79C3309581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894105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5534" y="609600"/>
            <a:ext cx="2554418" cy="2133600"/>
          </a:xfrm>
        </p:spPr>
        <p:txBody>
          <a:bodyPr anchor="b"/>
          <a:lstStyle>
            <a:lvl1pPr>
              <a:defRPr sz="277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67048" y="1316569"/>
            <a:ext cx="4009519" cy="6498167"/>
          </a:xfrm>
        </p:spPr>
        <p:txBody>
          <a:bodyPr anchor="t"/>
          <a:lstStyle>
            <a:lvl1pPr marL="0" indent="0">
              <a:buNone/>
              <a:defRPr sz="2772"/>
            </a:lvl1pPr>
            <a:lvl2pPr marL="395981" indent="0">
              <a:buNone/>
              <a:defRPr sz="2425"/>
            </a:lvl2pPr>
            <a:lvl3pPr marL="791962" indent="0">
              <a:buNone/>
              <a:defRPr sz="2079"/>
            </a:lvl3pPr>
            <a:lvl4pPr marL="1187943" indent="0">
              <a:buNone/>
              <a:defRPr sz="1732"/>
            </a:lvl4pPr>
            <a:lvl5pPr marL="1583924" indent="0">
              <a:buNone/>
              <a:defRPr sz="1732"/>
            </a:lvl5pPr>
            <a:lvl6pPr marL="1979905" indent="0">
              <a:buNone/>
              <a:defRPr sz="1732"/>
            </a:lvl6pPr>
            <a:lvl7pPr marL="2375886" indent="0">
              <a:buNone/>
              <a:defRPr sz="1732"/>
            </a:lvl7pPr>
            <a:lvl8pPr marL="2771866" indent="0">
              <a:buNone/>
              <a:defRPr sz="1732"/>
            </a:lvl8pPr>
            <a:lvl9pPr marL="3167847" indent="0">
              <a:buNone/>
              <a:defRPr sz="1732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45534" y="2743200"/>
            <a:ext cx="2554418" cy="5082117"/>
          </a:xfrm>
        </p:spPr>
        <p:txBody>
          <a:bodyPr/>
          <a:lstStyle>
            <a:lvl1pPr marL="0" indent="0">
              <a:buNone/>
              <a:defRPr sz="1386"/>
            </a:lvl1pPr>
            <a:lvl2pPr marL="395981" indent="0">
              <a:buNone/>
              <a:defRPr sz="1213"/>
            </a:lvl2pPr>
            <a:lvl3pPr marL="791962" indent="0">
              <a:buNone/>
              <a:defRPr sz="1039"/>
            </a:lvl3pPr>
            <a:lvl4pPr marL="1187943" indent="0">
              <a:buNone/>
              <a:defRPr sz="866"/>
            </a:lvl4pPr>
            <a:lvl5pPr marL="1583924" indent="0">
              <a:buNone/>
              <a:defRPr sz="866"/>
            </a:lvl5pPr>
            <a:lvl6pPr marL="1979905" indent="0">
              <a:buNone/>
              <a:defRPr sz="866"/>
            </a:lvl6pPr>
            <a:lvl7pPr marL="2375886" indent="0">
              <a:buNone/>
              <a:defRPr sz="866"/>
            </a:lvl7pPr>
            <a:lvl8pPr marL="2771866" indent="0">
              <a:buNone/>
              <a:defRPr sz="866"/>
            </a:lvl8pPr>
            <a:lvl9pPr marL="3167847" indent="0">
              <a:buNone/>
              <a:defRPr sz="866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18134-4681-4C19-9489-6E01CC32B0AC}" type="datetimeFigureOut">
              <a:rPr lang="zh-CN" altLang="en-US" smtClean="0"/>
              <a:t>2022/3/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4C929B-716C-4F10-932C-E79C3309581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752273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44503" y="486836"/>
            <a:ext cx="6831033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4503" y="2434167"/>
            <a:ext cx="6831033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44502" y="8475136"/>
            <a:ext cx="1782009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3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018134-4681-4C19-9489-6E01CC32B0AC}" type="datetimeFigureOut">
              <a:rPr lang="zh-CN" altLang="en-US" smtClean="0"/>
              <a:t>2022/3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623513" y="8475136"/>
            <a:ext cx="2673013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3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593527" y="8475136"/>
            <a:ext cx="1782009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3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4C929B-716C-4F10-932C-E79C3309581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290873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791962" rtl="0" eaLnBrk="1" latinLnBrk="0" hangingPunct="1">
        <a:lnSpc>
          <a:spcPct val="90000"/>
        </a:lnSpc>
        <a:spcBef>
          <a:spcPct val="0"/>
        </a:spcBef>
        <a:buNone/>
        <a:defRPr sz="381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7990" indent="-197990" algn="l" defTabSz="791962" rtl="0" eaLnBrk="1" latinLnBrk="0" hangingPunct="1">
        <a:lnSpc>
          <a:spcPct val="90000"/>
        </a:lnSpc>
        <a:spcBef>
          <a:spcPts val="866"/>
        </a:spcBef>
        <a:buFont typeface="Arial" panose="020B0604020202020204" pitchFamily="34" charset="0"/>
        <a:buChar char="•"/>
        <a:defRPr sz="2425" kern="1200">
          <a:solidFill>
            <a:schemeClr val="tx1"/>
          </a:solidFill>
          <a:latin typeface="+mn-lt"/>
          <a:ea typeface="+mn-ea"/>
          <a:cs typeface="+mn-cs"/>
        </a:defRPr>
      </a:lvl1pPr>
      <a:lvl2pPr marL="593971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2079" kern="1200">
          <a:solidFill>
            <a:schemeClr val="tx1"/>
          </a:solidFill>
          <a:latin typeface="+mn-lt"/>
          <a:ea typeface="+mn-ea"/>
          <a:cs typeface="+mn-cs"/>
        </a:defRPr>
      </a:lvl2pPr>
      <a:lvl3pPr marL="989952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732" kern="1200">
          <a:solidFill>
            <a:schemeClr val="tx1"/>
          </a:solidFill>
          <a:latin typeface="+mn-lt"/>
          <a:ea typeface="+mn-ea"/>
          <a:cs typeface="+mn-cs"/>
        </a:defRPr>
      </a:lvl3pPr>
      <a:lvl4pPr marL="1385933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559" kern="1200">
          <a:solidFill>
            <a:schemeClr val="tx1"/>
          </a:solidFill>
          <a:latin typeface="+mn-lt"/>
          <a:ea typeface="+mn-ea"/>
          <a:cs typeface="+mn-cs"/>
        </a:defRPr>
      </a:lvl4pPr>
      <a:lvl5pPr marL="1781914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559" kern="1200">
          <a:solidFill>
            <a:schemeClr val="tx1"/>
          </a:solidFill>
          <a:latin typeface="+mn-lt"/>
          <a:ea typeface="+mn-ea"/>
          <a:cs typeface="+mn-cs"/>
        </a:defRPr>
      </a:lvl5pPr>
      <a:lvl6pPr marL="2177895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559" kern="1200">
          <a:solidFill>
            <a:schemeClr val="tx1"/>
          </a:solidFill>
          <a:latin typeface="+mn-lt"/>
          <a:ea typeface="+mn-ea"/>
          <a:cs typeface="+mn-cs"/>
        </a:defRPr>
      </a:lvl6pPr>
      <a:lvl7pPr marL="2573876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559" kern="1200">
          <a:solidFill>
            <a:schemeClr val="tx1"/>
          </a:solidFill>
          <a:latin typeface="+mn-lt"/>
          <a:ea typeface="+mn-ea"/>
          <a:cs typeface="+mn-cs"/>
        </a:defRPr>
      </a:lvl7pPr>
      <a:lvl8pPr marL="2969857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559" kern="1200">
          <a:solidFill>
            <a:schemeClr val="tx1"/>
          </a:solidFill>
          <a:latin typeface="+mn-lt"/>
          <a:ea typeface="+mn-ea"/>
          <a:cs typeface="+mn-cs"/>
        </a:defRPr>
      </a:lvl8pPr>
      <a:lvl9pPr marL="3365838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55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1pPr>
      <a:lvl2pPr marL="395981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2pPr>
      <a:lvl3pPr marL="791962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3pPr>
      <a:lvl4pPr marL="1187943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4pPr>
      <a:lvl5pPr marL="1583924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5pPr>
      <a:lvl6pPr marL="1979905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6pPr>
      <a:lvl7pPr marL="2375886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7pPr>
      <a:lvl8pPr marL="2771866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8pPr>
      <a:lvl9pPr marL="3167847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5" Type="http://schemas.microsoft.com/office/2007/relationships/hdphoto" Target="../media/hdphoto2.wdp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1">
            <a:extLst>
              <a:ext uri="{FF2B5EF4-FFF2-40B4-BE49-F238E27FC236}">
                <a16:creationId xmlns:a16="http://schemas.microsoft.com/office/drawing/2014/main" id="{31D2E12F-B8CB-48CB-ACF8-345AB22C0B8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06476706"/>
              </p:ext>
            </p:extLst>
          </p:nvPr>
        </p:nvGraphicFramePr>
        <p:xfrm>
          <a:off x="1031232" y="1050727"/>
          <a:ext cx="6012117" cy="147938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781342">
                  <a:extLst>
                    <a:ext uri="{9D8B030D-6E8A-4147-A177-3AD203B41FA5}">
                      <a16:colId xmlns:a16="http://schemas.microsoft.com/office/drawing/2014/main" val="176710263"/>
                    </a:ext>
                  </a:extLst>
                </a:gridCol>
                <a:gridCol w="1781342">
                  <a:extLst>
                    <a:ext uri="{9D8B030D-6E8A-4147-A177-3AD203B41FA5}">
                      <a16:colId xmlns:a16="http://schemas.microsoft.com/office/drawing/2014/main" val="2399535514"/>
                    </a:ext>
                  </a:extLst>
                </a:gridCol>
                <a:gridCol w="2449433">
                  <a:extLst>
                    <a:ext uri="{9D8B030D-6E8A-4147-A177-3AD203B41FA5}">
                      <a16:colId xmlns:a16="http://schemas.microsoft.com/office/drawing/2014/main" val="1348495008"/>
                    </a:ext>
                  </a:extLst>
                </a:gridCol>
              </a:tblGrid>
              <a:tr h="382108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rms</a:t>
                      </a:r>
                      <a:endParaRPr lang="zh-CN" altLang="en-US" sz="12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 animal number</a:t>
                      </a:r>
                      <a:endParaRPr lang="zh-CN" altLang="en-US" sz="12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. and % of sampled animals</a:t>
                      </a:r>
                      <a:endParaRPr lang="zh-CN" altLang="en-US" sz="12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50876606"/>
                  </a:ext>
                </a:extLst>
              </a:tr>
              <a:tr h="273473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rm 1</a:t>
                      </a:r>
                      <a:endParaRPr lang="zh-CN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50</a:t>
                      </a:r>
                      <a:endParaRPr lang="zh-CN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 (4.2%)</a:t>
                      </a:r>
                      <a:endParaRPr lang="zh-CN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80085921"/>
                  </a:ext>
                </a:extLst>
              </a:tr>
              <a:tr h="273473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rm 2</a:t>
                      </a:r>
                      <a:endParaRPr lang="zh-CN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0</a:t>
                      </a:r>
                      <a:endParaRPr lang="zh-CN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 (15%)</a:t>
                      </a:r>
                      <a:endParaRPr lang="zh-CN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32146335"/>
                  </a:ext>
                </a:extLst>
              </a:tr>
              <a:tr h="273473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rm 3</a:t>
                      </a:r>
                      <a:endParaRPr lang="zh-CN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0</a:t>
                      </a:r>
                      <a:endParaRPr lang="zh-CN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0 (28.6%)</a:t>
                      </a:r>
                      <a:endParaRPr lang="zh-CN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41126119"/>
                  </a:ext>
                </a:extLst>
              </a:tr>
              <a:tr h="273473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</a:t>
                      </a:r>
                      <a:endParaRPr lang="zh-CN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60</a:t>
                      </a:r>
                      <a:endParaRPr lang="zh-CN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6 (10.8%)</a:t>
                      </a:r>
                      <a:endParaRPr lang="zh-CN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23603001"/>
                  </a:ext>
                </a:extLst>
              </a:tr>
            </a:tbl>
          </a:graphicData>
        </a:graphic>
      </p:graphicFrame>
      <p:sp>
        <p:nvSpPr>
          <p:cNvPr id="3" name="文本框 2">
            <a:extLst>
              <a:ext uri="{FF2B5EF4-FFF2-40B4-BE49-F238E27FC236}">
                <a16:creationId xmlns:a16="http://schemas.microsoft.com/office/drawing/2014/main" id="{60A58E8C-7317-4897-810A-4908CB84EFBA}"/>
              </a:ext>
            </a:extLst>
          </p:cNvPr>
          <p:cNvSpPr txBox="1"/>
          <p:nvPr/>
        </p:nvSpPr>
        <p:spPr>
          <a:xfrm>
            <a:off x="932378" y="576020"/>
            <a:ext cx="43266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16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sz="1200" dirty="0"/>
              <a:t>Supplementary Table 1 Sampling information of the herd</a:t>
            </a:r>
            <a:endParaRPr lang="zh-CN" altLang="en-US" sz="1200" dirty="0"/>
          </a:p>
        </p:txBody>
      </p:sp>
    </p:spTree>
    <p:extLst>
      <p:ext uri="{BB962C8B-B14F-4D97-AF65-F5344CB8AC3E}">
        <p14:creationId xmlns:p14="http://schemas.microsoft.com/office/powerpoint/2010/main" val="9826139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文本框 26">
            <a:extLst>
              <a:ext uri="{FF2B5EF4-FFF2-40B4-BE49-F238E27FC236}">
                <a16:creationId xmlns:a16="http://schemas.microsoft.com/office/drawing/2014/main" id="{287C770E-D75E-4187-B670-AE0AC1D8CBA7}"/>
              </a:ext>
            </a:extLst>
          </p:cNvPr>
          <p:cNvSpPr txBox="1"/>
          <p:nvPr/>
        </p:nvSpPr>
        <p:spPr>
          <a:xfrm>
            <a:off x="-23659" y="12344"/>
            <a:ext cx="20993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9" name="图片 28">
            <a:extLst>
              <a:ext uri="{FF2B5EF4-FFF2-40B4-BE49-F238E27FC236}">
                <a16:creationId xmlns:a16="http://schemas.microsoft.com/office/drawing/2014/main" id="{AE974E8E-4D8F-49C2-8166-A1EF9A359FD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2162" y="1302175"/>
            <a:ext cx="6761050" cy="3249450"/>
          </a:xfrm>
          <a:prstGeom prst="rect">
            <a:avLst/>
          </a:prstGeom>
        </p:spPr>
      </p:pic>
      <p:sp>
        <p:nvSpPr>
          <p:cNvPr id="44" name="文本框 43">
            <a:extLst>
              <a:ext uri="{FF2B5EF4-FFF2-40B4-BE49-F238E27FC236}">
                <a16:creationId xmlns:a16="http://schemas.microsoft.com/office/drawing/2014/main" id="{E902C98A-6F42-4C82-A550-64F4B3A390F6}"/>
              </a:ext>
            </a:extLst>
          </p:cNvPr>
          <p:cNvSpPr txBox="1"/>
          <p:nvPr/>
        </p:nvSpPr>
        <p:spPr>
          <a:xfrm>
            <a:off x="4417020" y="1401600"/>
            <a:ext cx="22172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KF234407.1/sheep/China Guangdong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77DE8D3D-DB9E-4633-B9D8-EDEA272ECE35}"/>
              </a:ext>
            </a:extLst>
          </p:cNvPr>
          <p:cNvSpPr txBox="1"/>
          <p:nvPr/>
        </p:nvSpPr>
        <p:spPr>
          <a:xfrm>
            <a:off x="4417020" y="1632432"/>
            <a:ext cx="154401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KY053526.1/sheep/China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1BD33027-2EB9-41C7-9C89-69EF060416E1}"/>
              </a:ext>
            </a:extLst>
          </p:cNvPr>
          <p:cNvSpPr txBox="1"/>
          <p:nvPr/>
        </p:nvSpPr>
        <p:spPr>
          <a:xfrm>
            <a:off x="4417020" y="1863651"/>
            <a:ext cx="183255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MG712417.1/sheep/China Jilin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8D6254A3-52C7-404A-BA74-1FC64F79E1F4}"/>
              </a:ext>
            </a:extLst>
          </p:cNvPr>
          <p:cNvSpPr txBox="1"/>
          <p:nvPr/>
        </p:nvSpPr>
        <p:spPr>
          <a:xfrm>
            <a:off x="4417020" y="2094096"/>
            <a:ext cx="157607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DQ184476.1/New Zealand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5C53B01B-CEA0-4A73-A39A-1748D408AD24}"/>
              </a:ext>
            </a:extLst>
          </p:cNvPr>
          <p:cNvSpPr txBox="1"/>
          <p:nvPr/>
        </p:nvSpPr>
        <p:spPr>
          <a:xfrm>
            <a:off x="4417020" y="2329029"/>
            <a:ext cx="14542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MN454854.1/ovine/USA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7AAEF3E0-46D0-43BC-A37E-317EA0ED3454}"/>
              </a:ext>
            </a:extLst>
          </p:cNvPr>
          <p:cNvSpPr txBox="1"/>
          <p:nvPr/>
        </p:nvSpPr>
        <p:spPr>
          <a:xfrm>
            <a:off x="4417020" y="2546598"/>
            <a:ext cx="17235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AY386263.1/ovine/USA Iowa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49B0A9CA-72C0-4A6D-B8EC-EADDAB0CFD45}"/>
              </a:ext>
            </a:extLst>
          </p:cNvPr>
          <p:cNvSpPr txBox="1"/>
          <p:nvPr/>
        </p:nvSpPr>
        <p:spPr>
          <a:xfrm>
            <a:off x="4417020" y="2780460"/>
            <a:ext cx="174278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MG674916.2/goat/China Jilin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1EA5C0FB-7DFF-47A6-8E99-38F8501481A4}"/>
              </a:ext>
            </a:extLst>
          </p:cNvPr>
          <p:cNvSpPr txBox="1"/>
          <p:nvPr/>
        </p:nvSpPr>
        <p:spPr>
          <a:xfrm>
            <a:off x="4417020" y="3004062"/>
            <a:ext cx="182614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KP010354.1/goat/China Fujian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1E9E9FD5-DC96-4585-9640-7EAEF230D541}"/>
              </a:ext>
            </a:extLst>
          </p:cNvPr>
          <p:cNvSpPr txBox="1"/>
          <p:nvPr/>
        </p:nvSpPr>
        <p:spPr>
          <a:xfrm>
            <a:off x="4418126" y="3218185"/>
            <a:ext cx="182614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KP010356.1/goat/China Fujian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77F50717-E002-4215-BF82-55AA8764EDD0}"/>
              </a:ext>
            </a:extLst>
          </p:cNvPr>
          <p:cNvSpPr txBox="1"/>
          <p:nvPr/>
        </p:nvSpPr>
        <p:spPr>
          <a:xfrm>
            <a:off x="4417020" y="3458696"/>
            <a:ext cx="140936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MT332357.1/goat/India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EA7D3F26-EF11-40C7-ACF5-DCE315A2361C}"/>
              </a:ext>
            </a:extLst>
          </p:cNvPr>
          <p:cNvSpPr txBox="1"/>
          <p:nvPr/>
        </p:nvSpPr>
        <p:spPr>
          <a:xfrm>
            <a:off x="4417020" y="3696163"/>
            <a:ext cx="174278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HM133903.1/sheep/Germany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6099480F-F812-4020-8FFA-E661416234A9}"/>
              </a:ext>
            </a:extLst>
          </p:cNvPr>
          <p:cNvSpPr txBox="1"/>
          <p:nvPr/>
        </p:nvSpPr>
        <p:spPr>
          <a:xfrm>
            <a:off x="4417020" y="3918273"/>
            <a:ext cx="192873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Saliva/dairy goat/China Shaanxi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18778721-A26E-41CD-A8C9-89C6B1BAAB12}"/>
              </a:ext>
            </a:extLst>
          </p:cNvPr>
          <p:cNvSpPr txBox="1"/>
          <p:nvPr/>
        </p:nvSpPr>
        <p:spPr>
          <a:xfrm>
            <a:off x="4417020" y="4148915"/>
            <a:ext cx="182614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Milk/dairy goat/China Shaanxi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2DD95DF0-B83C-4819-8226-C3312D236563}"/>
              </a:ext>
            </a:extLst>
          </p:cNvPr>
          <p:cNvSpPr txBox="1"/>
          <p:nvPr/>
        </p:nvSpPr>
        <p:spPr>
          <a:xfrm>
            <a:off x="3503019" y="1438176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2B0FD486-2B8F-4404-8A46-214C6355E37E}"/>
              </a:ext>
            </a:extLst>
          </p:cNvPr>
          <p:cNvSpPr txBox="1"/>
          <p:nvPr/>
        </p:nvSpPr>
        <p:spPr>
          <a:xfrm>
            <a:off x="3466969" y="4145171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id="{2E532F0D-CEAA-4ABF-8401-43420746EFB9}"/>
              </a:ext>
            </a:extLst>
          </p:cNvPr>
          <p:cNvSpPr txBox="1"/>
          <p:nvPr/>
        </p:nvSpPr>
        <p:spPr>
          <a:xfrm>
            <a:off x="2893944" y="4005575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id="{20CBE247-9054-4FD2-9FB9-35901321EDDA}"/>
              </a:ext>
            </a:extLst>
          </p:cNvPr>
          <p:cNvSpPr txBox="1"/>
          <p:nvPr/>
        </p:nvSpPr>
        <p:spPr>
          <a:xfrm>
            <a:off x="3494867" y="3512414"/>
            <a:ext cx="3770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66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27221F4C-A091-43A7-BB99-81D6495FC520}"/>
              </a:ext>
            </a:extLst>
          </p:cNvPr>
          <p:cNvSpPr txBox="1"/>
          <p:nvPr/>
        </p:nvSpPr>
        <p:spPr>
          <a:xfrm>
            <a:off x="2861675" y="3268327"/>
            <a:ext cx="3770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id="{A51807A5-C270-4905-83B0-EA2274B6F711}"/>
              </a:ext>
            </a:extLst>
          </p:cNvPr>
          <p:cNvSpPr txBox="1"/>
          <p:nvPr/>
        </p:nvSpPr>
        <p:spPr>
          <a:xfrm>
            <a:off x="3582992" y="2799021"/>
            <a:ext cx="3770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87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1150DC00-A71F-4977-9A08-0C82E72E7CF1}"/>
              </a:ext>
            </a:extLst>
          </p:cNvPr>
          <p:cNvSpPr txBox="1"/>
          <p:nvPr/>
        </p:nvSpPr>
        <p:spPr>
          <a:xfrm>
            <a:off x="3582992" y="2561528"/>
            <a:ext cx="3770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97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文本框 63">
            <a:extLst>
              <a:ext uri="{FF2B5EF4-FFF2-40B4-BE49-F238E27FC236}">
                <a16:creationId xmlns:a16="http://schemas.microsoft.com/office/drawing/2014/main" id="{749B53E5-D606-44FC-894C-8022090ED827}"/>
              </a:ext>
            </a:extLst>
          </p:cNvPr>
          <p:cNvSpPr txBox="1"/>
          <p:nvPr/>
        </p:nvSpPr>
        <p:spPr>
          <a:xfrm>
            <a:off x="1692467" y="2027890"/>
            <a:ext cx="3770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96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文本框 64">
            <a:extLst>
              <a:ext uri="{FF2B5EF4-FFF2-40B4-BE49-F238E27FC236}">
                <a16:creationId xmlns:a16="http://schemas.microsoft.com/office/drawing/2014/main" id="{67B6D8C7-168B-4E99-88BD-7DE996BD67BF}"/>
              </a:ext>
            </a:extLst>
          </p:cNvPr>
          <p:cNvSpPr txBox="1"/>
          <p:nvPr/>
        </p:nvSpPr>
        <p:spPr>
          <a:xfrm>
            <a:off x="2343689" y="1784424"/>
            <a:ext cx="3770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90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文本框 65">
            <a:extLst>
              <a:ext uri="{FF2B5EF4-FFF2-40B4-BE49-F238E27FC236}">
                <a16:creationId xmlns:a16="http://schemas.microsoft.com/office/drawing/2014/main" id="{BB138ECF-A273-42BF-B9AA-F7462CEF8630}"/>
              </a:ext>
            </a:extLst>
          </p:cNvPr>
          <p:cNvSpPr txBox="1"/>
          <p:nvPr/>
        </p:nvSpPr>
        <p:spPr>
          <a:xfrm>
            <a:off x="2923354" y="1589090"/>
            <a:ext cx="3770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53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星形: 四角 67">
            <a:extLst>
              <a:ext uri="{FF2B5EF4-FFF2-40B4-BE49-F238E27FC236}">
                <a16:creationId xmlns:a16="http://schemas.microsoft.com/office/drawing/2014/main" id="{F273BCEB-40F4-40EB-A921-192EB3CC42FA}"/>
              </a:ext>
            </a:extLst>
          </p:cNvPr>
          <p:cNvSpPr/>
          <p:nvPr/>
        </p:nvSpPr>
        <p:spPr>
          <a:xfrm>
            <a:off x="6295170" y="3995434"/>
            <a:ext cx="76782" cy="73237"/>
          </a:xfrm>
          <a:prstGeom prst="star4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b="1"/>
          </a:p>
        </p:txBody>
      </p:sp>
      <p:sp>
        <p:nvSpPr>
          <p:cNvPr id="69" name="星形: 四角 68">
            <a:extLst>
              <a:ext uri="{FF2B5EF4-FFF2-40B4-BE49-F238E27FC236}">
                <a16:creationId xmlns:a16="http://schemas.microsoft.com/office/drawing/2014/main" id="{096BD31F-B43F-4E5A-B233-13AB15878E4F}"/>
              </a:ext>
            </a:extLst>
          </p:cNvPr>
          <p:cNvSpPr/>
          <p:nvPr/>
        </p:nvSpPr>
        <p:spPr>
          <a:xfrm>
            <a:off x="6191476" y="4236160"/>
            <a:ext cx="76782" cy="73237"/>
          </a:xfrm>
          <a:prstGeom prst="star4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b="1"/>
          </a:p>
        </p:txBody>
      </p:sp>
      <p:sp>
        <p:nvSpPr>
          <p:cNvPr id="70" name="文本框 69">
            <a:extLst>
              <a:ext uri="{FF2B5EF4-FFF2-40B4-BE49-F238E27FC236}">
                <a16:creationId xmlns:a16="http://schemas.microsoft.com/office/drawing/2014/main" id="{D19553A9-4013-42F4-B101-03DD0BF3D1EC}"/>
              </a:ext>
            </a:extLst>
          </p:cNvPr>
          <p:cNvSpPr txBox="1"/>
          <p:nvPr/>
        </p:nvSpPr>
        <p:spPr>
          <a:xfrm>
            <a:off x="506152" y="1240888"/>
            <a:ext cx="2206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3" name="表格 15">
            <a:extLst>
              <a:ext uri="{FF2B5EF4-FFF2-40B4-BE49-F238E27FC236}">
                <a16:creationId xmlns:a16="http://schemas.microsoft.com/office/drawing/2014/main" id="{E84C6920-021A-4B16-A970-DA823D5AC29B}"/>
              </a:ext>
            </a:extLst>
          </p:cNvPr>
          <p:cNvGraphicFramePr>
            <a:graphicFrameLocks noGrp="1" noChangeAspect="1"/>
          </p:cNvGraphicFramePr>
          <p:nvPr>
            <p:extLst>
              <p:ext uri="{D42A27DB-BD31-4B8C-83A1-F6EECF244321}">
                <p14:modId xmlns:p14="http://schemas.microsoft.com/office/powerpoint/2010/main" val="2512869116"/>
              </p:ext>
            </p:extLst>
          </p:nvPr>
        </p:nvGraphicFramePr>
        <p:xfrm>
          <a:off x="628126" y="5025561"/>
          <a:ext cx="4705170" cy="2748742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13678">
                  <a:extLst>
                    <a:ext uri="{9D8B030D-6E8A-4147-A177-3AD203B41FA5}">
                      <a16:colId xmlns:a16="http://schemas.microsoft.com/office/drawing/2014/main" val="3483618224"/>
                    </a:ext>
                  </a:extLst>
                </a:gridCol>
                <a:gridCol w="313678">
                  <a:extLst>
                    <a:ext uri="{9D8B030D-6E8A-4147-A177-3AD203B41FA5}">
                      <a16:colId xmlns:a16="http://schemas.microsoft.com/office/drawing/2014/main" val="2306471087"/>
                    </a:ext>
                  </a:extLst>
                </a:gridCol>
                <a:gridCol w="313678">
                  <a:extLst>
                    <a:ext uri="{9D8B030D-6E8A-4147-A177-3AD203B41FA5}">
                      <a16:colId xmlns:a16="http://schemas.microsoft.com/office/drawing/2014/main" val="1402848105"/>
                    </a:ext>
                  </a:extLst>
                </a:gridCol>
                <a:gridCol w="313678">
                  <a:extLst>
                    <a:ext uri="{9D8B030D-6E8A-4147-A177-3AD203B41FA5}">
                      <a16:colId xmlns:a16="http://schemas.microsoft.com/office/drawing/2014/main" val="3435279296"/>
                    </a:ext>
                  </a:extLst>
                </a:gridCol>
                <a:gridCol w="313678">
                  <a:extLst>
                    <a:ext uri="{9D8B030D-6E8A-4147-A177-3AD203B41FA5}">
                      <a16:colId xmlns:a16="http://schemas.microsoft.com/office/drawing/2014/main" val="2233246625"/>
                    </a:ext>
                  </a:extLst>
                </a:gridCol>
                <a:gridCol w="313678">
                  <a:extLst>
                    <a:ext uri="{9D8B030D-6E8A-4147-A177-3AD203B41FA5}">
                      <a16:colId xmlns:a16="http://schemas.microsoft.com/office/drawing/2014/main" val="1519500420"/>
                    </a:ext>
                  </a:extLst>
                </a:gridCol>
                <a:gridCol w="313678">
                  <a:extLst>
                    <a:ext uri="{9D8B030D-6E8A-4147-A177-3AD203B41FA5}">
                      <a16:colId xmlns:a16="http://schemas.microsoft.com/office/drawing/2014/main" val="2258887881"/>
                    </a:ext>
                  </a:extLst>
                </a:gridCol>
                <a:gridCol w="313678">
                  <a:extLst>
                    <a:ext uri="{9D8B030D-6E8A-4147-A177-3AD203B41FA5}">
                      <a16:colId xmlns:a16="http://schemas.microsoft.com/office/drawing/2014/main" val="677683465"/>
                    </a:ext>
                  </a:extLst>
                </a:gridCol>
                <a:gridCol w="313678">
                  <a:extLst>
                    <a:ext uri="{9D8B030D-6E8A-4147-A177-3AD203B41FA5}">
                      <a16:colId xmlns:a16="http://schemas.microsoft.com/office/drawing/2014/main" val="1350491888"/>
                    </a:ext>
                  </a:extLst>
                </a:gridCol>
                <a:gridCol w="313678">
                  <a:extLst>
                    <a:ext uri="{9D8B030D-6E8A-4147-A177-3AD203B41FA5}">
                      <a16:colId xmlns:a16="http://schemas.microsoft.com/office/drawing/2014/main" val="4064125996"/>
                    </a:ext>
                  </a:extLst>
                </a:gridCol>
                <a:gridCol w="313678">
                  <a:extLst>
                    <a:ext uri="{9D8B030D-6E8A-4147-A177-3AD203B41FA5}">
                      <a16:colId xmlns:a16="http://schemas.microsoft.com/office/drawing/2014/main" val="1037332582"/>
                    </a:ext>
                  </a:extLst>
                </a:gridCol>
                <a:gridCol w="313678">
                  <a:extLst>
                    <a:ext uri="{9D8B030D-6E8A-4147-A177-3AD203B41FA5}">
                      <a16:colId xmlns:a16="http://schemas.microsoft.com/office/drawing/2014/main" val="681235717"/>
                    </a:ext>
                  </a:extLst>
                </a:gridCol>
                <a:gridCol w="313678">
                  <a:extLst>
                    <a:ext uri="{9D8B030D-6E8A-4147-A177-3AD203B41FA5}">
                      <a16:colId xmlns:a16="http://schemas.microsoft.com/office/drawing/2014/main" val="4104699233"/>
                    </a:ext>
                  </a:extLst>
                </a:gridCol>
                <a:gridCol w="313678">
                  <a:extLst>
                    <a:ext uri="{9D8B030D-6E8A-4147-A177-3AD203B41FA5}">
                      <a16:colId xmlns:a16="http://schemas.microsoft.com/office/drawing/2014/main" val="3822594497"/>
                    </a:ext>
                  </a:extLst>
                </a:gridCol>
                <a:gridCol w="313678">
                  <a:extLst>
                    <a:ext uri="{9D8B030D-6E8A-4147-A177-3AD203B41FA5}">
                      <a16:colId xmlns:a16="http://schemas.microsoft.com/office/drawing/2014/main" val="3903360216"/>
                    </a:ext>
                  </a:extLst>
                </a:gridCol>
              </a:tblGrid>
              <a:tr h="182193">
                <a:tc>
                  <a:txBody>
                    <a:bodyPr/>
                    <a:lstStyle/>
                    <a:p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95965206"/>
                  </a:ext>
                </a:extLst>
              </a:tr>
              <a:tr h="182193"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.2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.8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.9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.6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.6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.3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.5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.3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.5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4.9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.6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.7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70306504"/>
                  </a:ext>
                </a:extLst>
              </a:tr>
              <a:tr h="198040"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0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.5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.6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.3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1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.5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8.4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.5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.3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8.1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.0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.1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59304563"/>
                  </a:ext>
                </a:extLst>
              </a:tr>
              <a:tr h="182193"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3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8.9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0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.1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.5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.0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.4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8.5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.5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.0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.0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66196905"/>
                  </a:ext>
                </a:extLst>
              </a:tr>
              <a:tr h="182193"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2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4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8.6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.3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.4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.2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.3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8.8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.6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.7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.8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08046994"/>
                  </a:ext>
                </a:extLst>
              </a:tr>
              <a:tr h="182193"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6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8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.8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.2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.7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.2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.9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.2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.5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.6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32816244"/>
                  </a:ext>
                </a:extLst>
              </a:tr>
              <a:tr h="182193"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5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0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8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3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.2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.9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.1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.8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.5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.5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.6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89754534"/>
                  </a:ext>
                </a:extLst>
              </a:tr>
              <a:tr h="182193"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8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6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7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9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9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.6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9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.3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.6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.2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.3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53832842"/>
                  </a:ext>
                </a:extLst>
              </a:tr>
              <a:tr h="182193"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7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1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9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4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1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4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.5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.6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8.3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.4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.5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72247949"/>
                  </a:ext>
                </a:extLst>
              </a:tr>
              <a:tr h="182193"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9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6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7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8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9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9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.2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.5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.1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.2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04628910"/>
                  </a:ext>
                </a:extLst>
              </a:tr>
              <a:tr h="182193"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7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8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1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3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8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5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9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.2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.3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.3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53933363"/>
                  </a:ext>
                </a:extLst>
              </a:tr>
              <a:tr h="182193"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3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6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5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9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6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4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9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4.9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.0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27496321"/>
                  </a:ext>
                </a:extLst>
              </a:tr>
              <a:tr h="182193"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5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1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2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5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6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6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0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8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1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9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3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7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55168639"/>
                  </a:ext>
                </a:extLst>
              </a:tr>
              <a:tr h="182193"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4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0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1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4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5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5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9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7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0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8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2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49652348"/>
                  </a:ext>
                </a:extLst>
              </a:tr>
              <a:tr h="182193">
                <a:tc>
                  <a:txBody>
                    <a:bodyPr/>
                    <a:lstStyle/>
                    <a:p>
                      <a:endParaRPr lang="zh-CN" altLang="en-US" sz="9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zh-CN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" marR="766" marT="648" marB="648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91812086"/>
                  </a:ext>
                </a:extLst>
              </a:tr>
            </a:tbl>
          </a:graphicData>
        </a:graphic>
      </p:graphicFrame>
      <p:sp>
        <p:nvSpPr>
          <p:cNvPr id="74" name="文本框 73">
            <a:extLst>
              <a:ext uri="{FF2B5EF4-FFF2-40B4-BE49-F238E27FC236}">
                <a16:creationId xmlns:a16="http://schemas.microsoft.com/office/drawing/2014/main" id="{8304E61B-050D-4737-95EF-DC3A7EBD2A86}"/>
              </a:ext>
            </a:extLst>
          </p:cNvPr>
          <p:cNvSpPr txBox="1"/>
          <p:nvPr/>
        </p:nvSpPr>
        <p:spPr>
          <a:xfrm>
            <a:off x="5336874" y="6293557"/>
            <a:ext cx="22172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KF234407.1/sheep/China Guangdong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id="{216B4148-0D47-45BD-9F55-9FB1F6A7B4B3}"/>
              </a:ext>
            </a:extLst>
          </p:cNvPr>
          <p:cNvSpPr txBox="1"/>
          <p:nvPr/>
        </p:nvSpPr>
        <p:spPr>
          <a:xfrm>
            <a:off x="5336874" y="6665941"/>
            <a:ext cx="154401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KY053526.1/sheep/China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id="{7386554E-45A8-4D89-B83D-D7D56B6D4900}"/>
              </a:ext>
            </a:extLst>
          </p:cNvPr>
          <p:cNvSpPr txBox="1"/>
          <p:nvPr/>
        </p:nvSpPr>
        <p:spPr>
          <a:xfrm>
            <a:off x="5336874" y="7038325"/>
            <a:ext cx="183255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MG712417.1/sheep/China Jilin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文本框 76">
            <a:extLst>
              <a:ext uri="{FF2B5EF4-FFF2-40B4-BE49-F238E27FC236}">
                <a16:creationId xmlns:a16="http://schemas.microsoft.com/office/drawing/2014/main" id="{725FA855-40B1-475A-9C6C-B52F3EE515A1}"/>
              </a:ext>
            </a:extLst>
          </p:cNvPr>
          <p:cNvSpPr txBox="1"/>
          <p:nvPr/>
        </p:nvSpPr>
        <p:spPr>
          <a:xfrm>
            <a:off x="5336874" y="6479749"/>
            <a:ext cx="157607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DQ184476.1/New Zealand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文本框 77">
            <a:extLst>
              <a:ext uri="{FF2B5EF4-FFF2-40B4-BE49-F238E27FC236}">
                <a16:creationId xmlns:a16="http://schemas.microsoft.com/office/drawing/2014/main" id="{8CACAF96-5B50-4090-9D0D-3C06F52A6403}"/>
              </a:ext>
            </a:extLst>
          </p:cNvPr>
          <p:cNvSpPr txBox="1"/>
          <p:nvPr/>
        </p:nvSpPr>
        <p:spPr>
          <a:xfrm>
            <a:off x="5336874" y="5362597"/>
            <a:ext cx="14542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MN454854.1/ovine/USA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文本框 78">
            <a:extLst>
              <a:ext uri="{FF2B5EF4-FFF2-40B4-BE49-F238E27FC236}">
                <a16:creationId xmlns:a16="http://schemas.microsoft.com/office/drawing/2014/main" id="{E22D185C-C112-4A12-A6A8-E60FE8C26919}"/>
              </a:ext>
            </a:extLst>
          </p:cNvPr>
          <p:cNvSpPr txBox="1"/>
          <p:nvPr/>
        </p:nvSpPr>
        <p:spPr>
          <a:xfrm>
            <a:off x="5336874" y="6107365"/>
            <a:ext cx="17235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AY386263.1/ovine/USA Iowa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文本框 79">
            <a:extLst>
              <a:ext uri="{FF2B5EF4-FFF2-40B4-BE49-F238E27FC236}">
                <a16:creationId xmlns:a16="http://schemas.microsoft.com/office/drawing/2014/main" id="{6B779C04-8F5D-4963-9572-44B0568452A1}"/>
              </a:ext>
            </a:extLst>
          </p:cNvPr>
          <p:cNvSpPr txBox="1"/>
          <p:nvPr/>
        </p:nvSpPr>
        <p:spPr>
          <a:xfrm>
            <a:off x="5336874" y="5548789"/>
            <a:ext cx="174278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MG674916.2/goat/China Jilin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文本框 80">
            <a:extLst>
              <a:ext uri="{FF2B5EF4-FFF2-40B4-BE49-F238E27FC236}">
                <a16:creationId xmlns:a16="http://schemas.microsoft.com/office/drawing/2014/main" id="{23EF7AAA-A3E1-4BDC-915B-D1E02DC17B31}"/>
              </a:ext>
            </a:extLst>
          </p:cNvPr>
          <p:cNvSpPr txBox="1"/>
          <p:nvPr/>
        </p:nvSpPr>
        <p:spPr>
          <a:xfrm>
            <a:off x="5336874" y="5734981"/>
            <a:ext cx="182614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KP010354.1/goat/China Fujian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文本框 81">
            <a:extLst>
              <a:ext uri="{FF2B5EF4-FFF2-40B4-BE49-F238E27FC236}">
                <a16:creationId xmlns:a16="http://schemas.microsoft.com/office/drawing/2014/main" id="{6D08B700-DA47-4B9E-9E71-ED656CCE238A}"/>
              </a:ext>
            </a:extLst>
          </p:cNvPr>
          <p:cNvSpPr txBox="1"/>
          <p:nvPr/>
        </p:nvSpPr>
        <p:spPr>
          <a:xfrm>
            <a:off x="5336874" y="5921173"/>
            <a:ext cx="182614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KP010356.1/goat/China Fujian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文本框 82">
            <a:extLst>
              <a:ext uri="{FF2B5EF4-FFF2-40B4-BE49-F238E27FC236}">
                <a16:creationId xmlns:a16="http://schemas.microsoft.com/office/drawing/2014/main" id="{1B7D4AB7-2899-419F-BB59-970D612C7590}"/>
              </a:ext>
            </a:extLst>
          </p:cNvPr>
          <p:cNvSpPr txBox="1"/>
          <p:nvPr/>
        </p:nvSpPr>
        <p:spPr>
          <a:xfrm>
            <a:off x="5336874" y="6852133"/>
            <a:ext cx="140936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MT332357.1/goat/India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文本框 83">
            <a:extLst>
              <a:ext uri="{FF2B5EF4-FFF2-40B4-BE49-F238E27FC236}">
                <a16:creationId xmlns:a16="http://schemas.microsoft.com/office/drawing/2014/main" id="{46257CCF-5CCC-4EB3-B996-CF23DAAC7860}"/>
              </a:ext>
            </a:extLst>
          </p:cNvPr>
          <p:cNvSpPr txBox="1"/>
          <p:nvPr/>
        </p:nvSpPr>
        <p:spPr>
          <a:xfrm>
            <a:off x="5336874" y="5176405"/>
            <a:ext cx="174278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HM133903.1/sheep/Germany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文本框 84">
            <a:extLst>
              <a:ext uri="{FF2B5EF4-FFF2-40B4-BE49-F238E27FC236}">
                <a16:creationId xmlns:a16="http://schemas.microsoft.com/office/drawing/2014/main" id="{B9718AE8-005B-41BA-B5CB-84CF586F7200}"/>
              </a:ext>
            </a:extLst>
          </p:cNvPr>
          <p:cNvSpPr txBox="1"/>
          <p:nvPr/>
        </p:nvSpPr>
        <p:spPr>
          <a:xfrm>
            <a:off x="5336874" y="7224517"/>
            <a:ext cx="192873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Saliva/dairy goat/China Shaanxi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文本框 85">
            <a:extLst>
              <a:ext uri="{FF2B5EF4-FFF2-40B4-BE49-F238E27FC236}">
                <a16:creationId xmlns:a16="http://schemas.microsoft.com/office/drawing/2014/main" id="{E68C7CDD-B937-4AB0-88AE-AC8047214111}"/>
              </a:ext>
            </a:extLst>
          </p:cNvPr>
          <p:cNvSpPr txBox="1"/>
          <p:nvPr/>
        </p:nvSpPr>
        <p:spPr>
          <a:xfrm>
            <a:off x="5336874" y="7410711"/>
            <a:ext cx="182614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Milk/dairy goat/China Shaanxi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星形: 四角 86">
            <a:extLst>
              <a:ext uri="{FF2B5EF4-FFF2-40B4-BE49-F238E27FC236}">
                <a16:creationId xmlns:a16="http://schemas.microsoft.com/office/drawing/2014/main" id="{7327BB0D-2655-4D24-A66E-6CBEF554417E}"/>
              </a:ext>
            </a:extLst>
          </p:cNvPr>
          <p:cNvSpPr/>
          <p:nvPr/>
        </p:nvSpPr>
        <p:spPr>
          <a:xfrm>
            <a:off x="7202511" y="7293541"/>
            <a:ext cx="76782" cy="73237"/>
          </a:xfrm>
          <a:prstGeom prst="star4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b="1"/>
          </a:p>
        </p:txBody>
      </p:sp>
      <p:sp>
        <p:nvSpPr>
          <p:cNvPr id="88" name="星形: 四角 87">
            <a:extLst>
              <a:ext uri="{FF2B5EF4-FFF2-40B4-BE49-F238E27FC236}">
                <a16:creationId xmlns:a16="http://schemas.microsoft.com/office/drawing/2014/main" id="{54B6F6F8-23F1-48B1-A357-B7579742651B}"/>
              </a:ext>
            </a:extLst>
          </p:cNvPr>
          <p:cNvSpPr/>
          <p:nvPr/>
        </p:nvSpPr>
        <p:spPr>
          <a:xfrm>
            <a:off x="7099138" y="7499280"/>
            <a:ext cx="76782" cy="73237"/>
          </a:xfrm>
          <a:prstGeom prst="star4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b="1"/>
          </a:p>
        </p:txBody>
      </p:sp>
      <p:sp>
        <p:nvSpPr>
          <p:cNvPr id="89" name="文本框 88">
            <a:extLst>
              <a:ext uri="{FF2B5EF4-FFF2-40B4-BE49-F238E27FC236}">
                <a16:creationId xmlns:a16="http://schemas.microsoft.com/office/drawing/2014/main" id="{E481F49B-82F0-4814-B305-A9FEBF12DB3A}"/>
              </a:ext>
            </a:extLst>
          </p:cNvPr>
          <p:cNvSpPr txBox="1"/>
          <p:nvPr/>
        </p:nvSpPr>
        <p:spPr>
          <a:xfrm>
            <a:off x="506152" y="4377566"/>
            <a:ext cx="2206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126044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文本框 26">
            <a:extLst>
              <a:ext uri="{FF2B5EF4-FFF2-40B4-BE49-F238E27FC236}">
                <a16:creationId xmlns:a16="http://schemas.microsoft.com/office/drawing/2014/main" id="{287C770E-D75E-4187-B670-AE0AC1D8CBA7}"/>
              </a:ext>
            </a:extLst>
          </p:cNvPr>
          <p:cNvSpPr txBox="1"/>
          <p:nvPr/>
        </p:nvSpPr>
        <p:spPr>
          <a:xfrm>
            <a:off x="-23659" y="12344"/>
            <a:ext cx="20993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文本框 77">
            <a:extLst>
              <a:ext uri="{FF2B5EF4-FFF2-40B4-BE49-F238E27FC236}">
                <a16:creationId xmlns:a16="http://schemas.microsoft.com/office/drawing/2014/main" id="{61A17B28-7C9E-44BE-993C-73FDA9BFF505}"/>
              </a:ext>
            </a:extLst>
          </p:cNvPr>
          <p:cNvSpPr txBox="1"/>
          <p:nvPr/>
        </p:nvSpPr>
        <p:spPr>
          <a:xfrm>
            <a:off x="604462" y="1154692"/>
            <a:ext cx="2206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文本框 16">
            <a:extLst>
              <a:ext uri="{FF2B5EF4-FFF2-40B4-BE49-F238E27FC236}">
                <a16:creationId xmlns:a16="http://schemas.microsoft.com/office/drawing/2014/main" id="{BBFC413D-F15D-4198-8692-BA10C093C4D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59831" y="1572221"/>
            <a:ext cx="851723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2000bp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文本框 16">
            <a:extLst>
              <a:ext uri="{FF2B5EF4-FFF2-40B4-BE49-F238E27FC236}">
                <a16:creationId xmlns:a16="http://schemas.microsoft.com/office/drawing/2014/main" id="{4C46099A-26D2-4E96-B0A2-5FE711E4EF4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59831" y="1863773"/>
            <a:ext cx="851723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1000bp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文本框 78">
            <a:extLst>
              <a:ext uri="{FF2B5EF4-FFF2-40B4-BE49-F238E27FC236}">
                <a16:creationId xmlns:a16="http://schemas.microsoft.com/office/drawing/2014/main" id="{3032D090-52A2-4696-85CB-00F8400BF418}"/>
              </a:ext>
            </a:extLst>
          </p:cNvPr>
          <p:cNvSpPr txBox="1"/>
          <p:nvPr/>
        </p:nvSpPr>
        <p:spPr>
          <a:xfrm>
            <a:off x="4023985" y="1154692"/>
            <a:ext cx="2206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511151B6-6F19-4AE2-924A-57C54CB66F46}"/>
              </a:ext>
            </a:extLst>
          </p:cNvPr>
          <p:cNvPicPr preferRelativeResize="0"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25000"/>
                    </a14:imgEffect>
                    <a14:imgEffect>
                      <a14:brightnessContrast bright="45000" contras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9544" t="42503" r="51232" b="31928"/>
          <a:stretch/>
        </p:blipFill>
        <p:spPr>
          <a:xfrm>
            <a:off x="4495033" y="1590447"/>
            <a:ext cx="2275182" cy="1492967"/>
          </a:xfrm>
          <a:prstGeom prst="rect">
            <a:avLst/>
          </a:prstGeom>
        </p:spPr>
      </p:pic>
      <p:sp>
        <p:nvSpPr>
          <p:cNvPr id="53" name="文本框 18">
            <a:extLst>
              <a:ext uri="{FF2B5EF4-FFF2-40B4-BE49-F238E27FC236}">
                <a16:creationId xmlns:a16="http://schemas.microsoft.com/office/drawing/2014/main" id="{B57DE3B1-5A00-423F-B6A8-9E78C0BDDEE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37068" y="1400845"/>
            <a:ext cx="288090" cy="2308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文本框 19">
            <a:extLst>
              <a:ext uri="{FF2B5EF4-FFF2-40B4-BE49-F238E27FC236}">
                <a16:creationId xmlns:a16="http://schemas.microsoft.com/office/drawing/2014/main" id="{387E5EAE-9348-4062-A6F7-D88B7CD79DC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55457" y="1400845"/>
            <a:ext cx="288090" cy="2308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文本框 20">
            <a:extLst>
              <a:ext uri="{FF2B5EF4-FFF2-40B4-BE49-F238E27FC236}">
                <a16:creationId xmlns:a16="http://schemas.microsoft.com/office/drawing/2014/main" id="{DD244D2E-71F9-4916-8416-12FA3CC56E8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73846" y="1400845"/>
            <a:ext cx="288090" cy="2308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文本框 16">
            <a:extLst>
              <a:ext uri="{FF2B5EF4-FFF2-40B4-BE49-F238E27FC236}">
                <a16:creationId xmlns:a16="http://schemas.microsoft.com/office/drawing/2014/main" id="{F88BAF6C-E11D-44E6-9302-29498352FAD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18679" y="1400845"/>
            <a:ext cx="288090" cy="2308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文本框 16">
            <a:extLst>
              <a:ext uri="{FF2B5EF4-FFF2-40B4-BE49-F238E27FC236}">
                <a16:creationId xmlns:a16="http://schemas.microsoft.com/office/drawing/2014/main" id="{98536DF2-2B1D-4881-80F1-7CE88E912AA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18446" y="2012228"/>
            <a:ext cx="851723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750bp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文本框 16">
            <a:extLst>
              <a:ext uri="{FF2B5EF4-FFF2-40B4-BE49-F238E27FC236}">
                <a16:creationId xmlns:a16="http://schemas.microsoft.com/office/drawing/2014/main" id="{A8A5158D-2D85-42F7-A61C-24FE6A40E36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23985" y="2210863"/>
            <a:ext cx="851723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500bp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文本框 16">
            <a:extLst>
              <a:ext uri="{FF2B5EF4-FFF2-40B4-BE49-F238E27FC236}">
                <a16:creationId xmlns:a16="http://schemas.microsoft.com/office/drawing/2014/main" id="{C097B599-3823-4BAC-A630-6ABCBDD36C6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16421" y="2561030"/>
            <a:ext cx="851723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250bp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文本框 16">
            <a:extLst>
              <a:ext uri="{FF2B5EF4-FFF2-40B4-BE49-F238E27FC236}">
                <a16:creationId xmlns:a16="http://schemas.microsoft.com/office/drawing/2014/main" id="{4479734D-A63C-443A-978E-DEB71D64570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16421" y="2852582"/>
            <a:ext cx="851723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100bp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id="{F3713E84-B08F-4946-AD5E-055A7EF50ED0}"/>
              </a:ext>
            </a:extLst>
          </p:cNvPr>
          <p:cNvSpPr txBox="1"/>
          <p:nvPr/>
        </p:nvSpPr>
        <p:spPr>
          <a:xfrm>
            <a:off x="6709255" y="2242463"/>
            <a:ext cx="59707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514bp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文本框 20">
            <a:extLst>
              <a:ext uri="{FF2B5EF4-FFF2-40B4-BE49-F238E27FC236}">
                <a16:creationId xmlns:a16="http://schemas.microsoft.com/office/drawing/2014/main" id="{EC87C857-BF91-46CD-AC07-FADFD27B864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92234" y="1400820"/>
            <a:ext cx="318389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文本框 20">
            <a:extLst>
              <a:ext uri="{FF2B5EF4-FFF2-40B4-BE49-F238E27FC236}">
                <a16:creationId xmlns:a16="http://schemas.microsoft.com/office/drawing/2014/main" id="{F933D732-B417-488E-BAE6-E0487F5D0C4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110623" y="1400820"/>
            <a:ext cx="358871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文本框 20">
            <a:extLst>
              <a:ext uri="{FF2B5EF4-FFF2-40B4-BE49-F238E27FC236}">
                <a16:creationId xmlns:a16="http://schemas.microsoft.com/office/drawing/2014/main" id="{53950860-3FA0-4770-A262-A12A7C30168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429015" y="1400820"/>
            <a:ext cx="509450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26D7C4BC-2C16-41A9-8DCE-578881D90779}"/>
              </a:ext>
            </a:extLst>
          </p:cNvPr>
          <p:cNvSpPr txBox="1"/>
          <p:nvPr/>
        </p:nvSpPr>
        <p:spPr>
          <a:xfrm>
            <a:off x="1144673" y="1400820"/>
            <a:ext cx="27709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40004962-6439-4272-917A-DAFF1B633AC5}"/>
              </a:ext>
            </a:extLst>
          </p:cNvPr>
          <p:cNvSpPr txBox="1"/>
          <p:nvPr/>
        </p:nvSpPr>
        <p:spPr>
          <a:xfrm>
            <a:off x="2776382" y="2255627"/>
            <a:ext cx="59707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514bp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18">
            <a:extLst>
              <a:ext uri="{FF2B5EF4-FFF2-40B4-BE49-F238E27FC236}">
                <a16:creationId xmlns:a16="http://schemas.microsoft.com/office/drawing/2014/main" id="{98D0ABA0-948B-49F6-9CE7-E00269BB983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16429" y="1400845"/>
            <a:ext cx="288090" cy="2308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18">
            <a:extLst>
              <a:ext uri="{FF2B5EF4-FFF2-40B4-BE49-F238E27FC236}">
                <a16:creationId xmlns:a16="http://schemas.microsoft.com/office/drawing/2014/main" id="{EC5296C7-58CA-4E45-9F8D-2EFF8BBBE72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99184" y="1400845"/>
            <a:ext cx="288090" cy="2308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18">
            <a:extLst>
              <a:ext uri="{FF2B5EF4-FFF2-40B4-BE49-F238E27FC236}">
                <a16:creationId xmlns:a16="http://schemas.microsoft.com/office/drawing/2014/main" id="{92227405-82E3-4C26-9AF2-229CBF203DA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81939" y="1400845"/>
            <a:ext cx="288090" cy="2308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本框 18">
            <a:extLst>
              <a:ext uri="{FF2B5EF4-FFF2-40B4-BE49-F238E27FC236}">
                <a16:creationId xmlns:a16="http://schemas.microsoft.com/office/drawing/2014/main" id="{3A3BA335-252A-4854-99D3-E0856D047B8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64694" y="1400845"/>
            <a:ext cx="288090" cy="2308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文本框 18">
            <a:extLst>
              <a:ext uri="{FF2B5EF4-FFF2-40B4-BE49-F238E27FC236}">
                <a16:creationId xmlns:a16="http://schemas.microsoft.com/office/drawing/2014/main" id="{A26331E4-719C-4BC7-BDFF-B0CFEFD2BEC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47447" y="1400845"/>
            <a:ext cx="288090" cy="2308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5" name="图片 44">
            <a:extLst>
              <a:ext uri="{FF2B5EF4-FFF2-40B4-BE49-F238E27FC236}">
                <a16:creationId xmlns:a16="http://schemas.microsoft.com/office/drawing/2014/main" id="{4FD39ED8-CBB0-40B2-ADE9-3AF85787ADA6}"/>
              </a:ext>
            </a:extLst>
          </p:cNvPr>
          <p:cNvPicPr preferRelativeResize="0"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30000"/>
                    </a14:imgEffect>
                    <a14:imgEffect>
                      <a14:brightnessContrast bright="20000" contrast="1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6853" t="40095" r="22329" b="33962"/>
          <a:stretch/>
        </p:blipFill>
        <p:spPr>
          <a:xfrm>
            <a:off x="1007694" y="1578799"/>
            <a:ext cx="1791791" cy="1674692"/>
          </a:xfrm>
          <a:prstGeom prst="rect">
            <a:avLst/>
          </a:prstGeom>
        </p:spPr>
      </p:pic>
      <p:sp>
        <p:nvSpPr>
          <p:cNvPr id="46" name="文本框 16">
            <a:extLst>
              <a:ext uri="{FF2B5EF4-FFF2-40B4-BE49-F238E27FC236}">
                <a16:creationId xmlns:a16="http://schemas.microsoft.com/office/drawing/2014/main" id="{7D60D0BE-F363-4F0C-815C-4333446635A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99217" y="1632419"/>
            <a:ext cx="851723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2000bp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文本框 16">
            <a:extLst>
              <a:ext uri="{FF2B5EF4-FFF2-40B4-BE49-F238E27FC236}">
                <a16:creationId xmlns:a16="http://schemas.microsoft.com/office/drawing/2014/main" id="{735277FD-C549-4971-88A6-6D50D2E042D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99217" y="1949084"/>
            <a:ext cx="851723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1000bp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16">
            <a:extLst>
              <a:ext uri="{FF2B5EF4-FFF2-40B4-BE49-F238E27FC236}">
                <a16:creationId xmlns:a16="http://schemas.microsoft.com/office/drawing/2014/main" id="{0F18752E-E69B-4A25-BE32-2C931D60401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7985" y="2122038"/>
            <a:ext cx="851723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750bp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本框 16">
            <a:extLst>
              <a:ext uri="{FF2B5EF4-FFF2-40B4-BE49-F238E27FC236}">
                <a16:creationId xmlns:a16="http://schemas.microsoft.com/office/drawing/2014/main" id="{1914BC68-7A67-471F-B4D6-42217DAB7D2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7985" y="2321678"/>
            <a:ext cx="851723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500bp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文本框 16">
            <a:extLst>
              <a:ext uri="{FF2B5EF4-FFF2-40B4-BE49-F238E27FC236}">
                <a16:creationId xmlns:a16="http://schemas.microsoft.com/office/drawing/2014/main" id="{FD18AC7E-5FC2-4700-A381-C183FC2A4F6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7985" y="2611657"/>
            <a:ext cx="851723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250bp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文本框 16">
            <a:extLst>
              <a:ext uri="{FF2B5EF4-FFF2-40B4-BE49-F238E27FC236}">
                <a16:creationId xmlns:a16="http://schemas.microsoft.com/office/drawing/2014/main" id="{8043788C-0BEA-4065-A2DB-96AD7C58D3E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7985" y="2907067"/>
            <a:ext cx="851723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100bp</a:t>
            </a:r>
            <a:endParaRPr lang="zh-CN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" name="直接箭头连接符 2">
            <a:extLst>
              <a:ext uri="{FF2B5EF4-FFF2-40B4-BE49-F238E27FC236}">
                <a16:creationId xmlns:a16="http://schemas.microsoft.com/office/drawing/2014/main" id="{E671C742-EAD8-40BA-B0CC-2707F78BF2B6}"/>
              </a:ext>
            </a:extLst>
          </p:cNvPr>
          <p:cNvCxnSpPr>
            <a:stCxn id="36" idx="1"/>
          </p:cNvCxnSpPr>
          <p:nvPr/>
        </p:nvCxnSpPr>
        <p:spPr>
          <a:xfrm flipH="1" flipV="1">
            <a:off x="2031177" y="2370446"/>
            <a:ext cx="745205" cy="597"/>
          </a:xfrm>
          <a:prstGeom prst="straightConnector1">
            <a:avLst/>
          </a:prstGeom>
          <a:ln w="19050">
            <a:solidFill>
              <a:srgbClr val="FFFF0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7958680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621</TotalTime>
  <Words>449</Words>
  <Application>Microsoft Office PowerPoint</Application>
  <PresentationFormat>自定义</PresentationFormat>
  <Paragraphs>293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8" baseType="lpstr">
      <vt:lpstr>等线</vt:lpstr>
      <vt:lpstr>Arial</vt:lpstr>
      <vt:lpstr>Calibri</vt:lpstr>
      <vt:lpstr>Calibri Light</vt:lpstr>
      <vt:lpstr>Office 主题​​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</dc:creator>
  <cp:lastModifiedBy>User</cp:lastModifiedBy>
  <cp:revision>53</cp:revision>
  <dcterms:created xsi:type="dcterms:W3CDTF">2021-05-11T08:25:46Z</dcterms:created>
  <dcterms:modified xsi:type="dcterms:W3CDTF">2022-03-02T02:59:49Z</dcterms:modified>
</cp:coreProperties>
</file>